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9" r:id="rId4"/>
    <p:sldId id="260" r:id="rId5"/>
    <p:sldId id="261" r:id="rId6"/>
    <p:sldId id="262" r:id="rId7"/>
  </p:sldIdLst>
  <p:sldSz cx="14630400" cy="82296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5" d="100"/>
          <a:sy n="95" d="100"/>
        </p:scale>
        <p:origin x="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28800" y="1346836"/>
            <a:ext cx="10972800" cy="286512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4322446"/>
            <a:ext cx="10972800" cy="198691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481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169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69880" y="438150"/>
            <a:ext cx="3154680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05840" y="438150"/>
            <a:ext cx="9281160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63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707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8220" y="2051686"/>
            <a:ext cx="12618720" cy="342328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8220" y="5507356"/>
            <a:ext cx="12618720" cy="180022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401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05840" y="2190750"/>
            <a:ext cx="621792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06640" y="2190750"/>
            <a:ext cx="621792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278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438150"/>
            <a:ext cx="1261872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7746" y="2017396"/>
            <a:ext cx="6189344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7746" y="3006090"/>
            <a:ext cx="6189344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06640" y="2017396"/>
            <a:ext cx="6219826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06640" y="3006090"/>
            <a:ext cx="6219826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411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558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489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548640"/>
            <a:ext cx="4718684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19826" y="1184911"/>
            <a:ext cx="7406640" cy="58483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2468880"/>
            <a:ext cx="4718684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600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548640"/>
            <a:ext cx="4718684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19826" y="1184911"/>
            <a:ext cx="7406640" cy="58483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2468880"/>
            <a:ext cx="4718684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324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05840" y="438150"/>
            <a:ext cx="1261872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5840" y="2190750"/>
            <a:ext cx="1261872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05840" y="7627621"/>
            <a:ext cx="329184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47EC14-DD6A-4200-ABF7-B9086F32E90F}" type="datetimeFigureOut">
              <a:rPr lang="en-US" smtClean="0"/>
              <a:t>1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6320" y="7627621"/>
            <a:ext cx="493776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32720" y="7627621"/>
            <a:ext cx="329184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8BA75-2957-4D6C-80B3-E3DDBC948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615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2B6FC8A-E659-4815-A634-A73E168FBD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7116" y="1234168"/>
            <a:ext cx="6544955" cy="5351117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2E813E3E-C044-4E92-82B8-B467347A1AA2}"/>
              </a:ext>
            </a:extLst>
          </p:cNvPr>
          <p:cNvCxnSpPr>
            <a:cxnSpLocks/>
          </p:cNvCxnSpPr>
          <p:nvPr/>
        </p:nvCxnSpPr>
        <p:spPr>
          <a:xfrm>
            <a:off x="2404757" y="1605207"/>
            <a:ext cx="0" cy="4970106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Picture 5">
            <a:extLst>
              <a:ext uri="{FF2B5EF4-FFF2-40B4-BE49-F238E27FC236}">
                <a16:creationId xmlns:a16="http://schemas.microsoft.com/office/drawing/2014/main" id="{6B231835-DEAD-4372-BCE1-ABD2EB6F03F9}"/>
              </a:ext>
            </a:extLst>
          </p:cNvPr>
          <p:cNvPicPr>
            <a:picLocks noChangeAspect="1"/>
          </p:cNvPicPr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7578845" y="1445311"/>
            <a:ext cx="6676913" cy="3797771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4B4A19B5-EFF7-4C39-80BC-968065F32E41}"/>
              </a:ext>
            </a:extLst>
          </p:cNvPr>
          <p:cNvCxnSpPr>
            <a:cxnSpLocks/>
          </p:cNvCxnSpPr>
          <p:nvPr/>
        </p:nvCxnSpPr>
        <p:spPr>
          <a:xfrm>
            <a:off x="10977326" y="1621485"/>
            <a:ext cx="0" cy="3611656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485F406E-6C5A-4702-B096-F225CE2A87CE}"/>
              </a:ext>
            </a:extLst>
          </p:cNvPr>
          <p:cNvSpPr txBox="1"/>
          <p:nvPr/>
        </p:nvSpPr>
        <p:spPr>
          <a:xfrm>
            <a:off x="149438" y="149625"/>
            <a:ext cx="3204467" cy="4912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92" dirty="0"/>
              <a:t>Supplemental Figure 1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C12AA18-4CE7-4050-8A66-2208D77362FC}"/>
              </a:ext>
            </a:extLst>
          </p:cNvPr>
          <p:cNvSpPr/>
          <p:nvPr/>
        </p:nvSpPr>
        <p:spPr>
          <a:xfrm>
            <a:off x="149438" y="745168"/>
            <a:ext cx="420308" cy="68326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840" dirty="0"/>
              <a:t>a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3B66FC3-4B10-4E9D-A685-BF1BA3D2B305}"/>
              </a:ext>
            </a:extLst>
          </p:cNvPr>
          <p:cNvSpPr/>
          <p:nvPr/>
        </p:nvSpPr>
        <p:spPr>
          <a:xfrm>
            <a:off x="7079968" y="745168"/>
            <a:ext cx="442750" cy="68326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840" dirty="0"/>
              <a:t>b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1EABC74-051F-4084-8E92-4BFACCDC90C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4246" t="232" r="29974" b="95640"/>
          <a:stretch/>
        </p:blipFill>
        <p:spPr>
          <a:xfrm>
            <a:off x="11266015" y="1216289"/>
            <a:ext cx="1032785" cy="2209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2090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Exp69-Heatmap-NormalizedCountYoung3%vsYoung20%-DECellDeathGenes-ColorRange-2to2.jpg">
            <a:extLst>
              <a:ext uri="{FF2B5EF4-FFF2-40B4-BE49-F238E27FC236}">
                <a16:creationId xmlns:a16="http://schemas.microsoft.com/office/drawing/2014/main" id="{A1EEFAD4-736A-49D6-9E9D-09C31E39C53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0357" y="1167029"/>
            <a:ext cx="2728622" cy="6355000"/>
          </a:xfrm>
          <a:prstGeom prst="rect">
            <a:avLst/>
          </a:prstGeom>
        </p:spPr>
      </p:pic>
      <p:pic>
        <p:nvPicPr>
          <p:cNvPr id="3" name="Picture 2" descr="Exp69-Heatmap-NormalizedCount0Old3%vsYoung3%-DECellDeathGenes-ColorRange-2to2.jpg">
            <a:extLst>
              <a:ext uri="{FF2B5EF4-FFF2-40B4-BE49-F238E27FC236}">
                <a16:creationId xmlns:a16="http://schemas.microsoft.com/office/drawing/2014/main" id="{8975949D-67F7-4E73-B5F4-009E416B823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5527" y="1142739"/>
            <a:ext cx="1518197" cy="6336981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94E09367-794B-4F44-AC40-5DB1CD53ED70}"/>
              </a:ext>
            </a:extLst>
          </p:cNvPr>
          <p:cNvGrpSpPr/>
          <p:nvPr/>
        </p:nvGrpSpPr>
        <p:grpSpPr>
          <a:xfrm>
            <a:off x="4374038" y="5517232"/>
            <a:ext cx="261610" cy="1346377"/>
            <a:chOff x="3544673" y="5283209"/>
            <a:chExt cx="261610" cy="1346377"/>
          </a:xfrm>
        </p:grpSpPr>
        <p:pic>
          <p:nvPicPr>
            <p:cNvPr id="5" name="Picture 4" descr="Exp69-Heatmap-NormalizedCountYoung3%vsYoung20%-DECellDeathGenes-ColorRange-2to2.jpg">
              <a:extLst>
                <a:ext uri="{FF2B5EF4-FFF2-40B4-BE49-F238E27FC236}">
                  <a16:creationId xmlns:a16="http://schemas.microsoft.com/office/drawing/2014/main" id="{0F4E10C7-919D-4E12-9C38-6DED624959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88" t="27880" r="41869" b="71644"/>
            <a:stretch/>
          </p:blipFill>
          <p:spPr>
            <a:xfrm rot="16200000">
              <a:off x="3478927" y="5581648"/>
              <a:ext cx="417004" cy="154781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6BA1B95-AF22-4E34-8494-B9D71819D6F1}"/>
                </a:ext>
              </a:extLst>
            </p:cNvPr>
            <p:cNvSpPr txBox="1"/>
            <p:nvPr/>
          </p:nvSpPr>
          <p:spPr>
            <a:xfrm rot="16200000">
              <a:off x="3002289" y="5825593"/>
              <a:ext cx="13463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 Scale: log</a:t>
              </a:r>
              <a:r>
                <a:rPr lang="en-US" sz="1100" baseline="-25000" dirty="0"/>
                <a:t>2</a:t>
              </a:r>
              <a:r>
                <a:rPr lang="en-US" sz="1100" dirty="0"/>
                <a:t>(-2 | +2)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86C72A8F-17A1-4A9F-B12A-A94709BFE866}"/>
              </a:ext>
            </a:extLst>
          </p:cNvPr>
          <p:cNvSpPr txBox="1"/>
          <p:nvPr/>
        </p:nvSpPr>
        <p:spPr>
          <a:xfrm>
            <a:off x="601573" y="370351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E770D39-CFC5-4152-8D97-914EDD90A113}"/>
              </a:ext>
            </a:extLst>
          </p:cNvPr>
          <p:cNvSpPr/>
          <p:nvPr/>
        </p:nvSpPr>
        <p:spPr>
          <a:xfrm>
            <a:off x="1460108" y="858614"/>
            <a:ext cx="38183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/>
              <a:t>a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977089A-7222-4308-8255-AC262CA7BC2F}"/>
              </a:ext>
            </a:extLst>
          </p:cNvPr>
          <p:cNvSpPr/>
          <p:nvPr/>
        </p:nvSpPr>
        <p:spPr>
          <a:xfrm>
            <a:off x="4548214" y="882677"/>
            <a:ext cx="401072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10683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 up of a necklace&#10;&#10;Description automatically generated">
            <a:extLst>
              <a:ext uri="{FF2B5EF4-FFF2-40B4-BE49-F238E27FC236}">
                <a16:creationId xmlns:a16="http://schemas.microsoft.com/office/drawing/2014/main" id="{ED57369A-A56C-48B5-A3EC-8B5E9D3FCD4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32" t="4643" r="34556" b="-1423"/>
          <a:stretch/>
        </p:blipFill>
        <p:spPr>
          <a:xfrm>
            <a:off x="3179896" y="726780"/>
            <a:ext cx="3805331" cy="5404441"/>
          </a:xfrm>
          <a:prstGeom prst="rect">
            <a:avLst/>
          </a:prstGeom>
        </p:spPr>
      </p:pic>
      <p:pic>
        <p:nvPicPr>
          <p:cNvPr id="3" name="Picture 2" descr="A picture containing drawing&#10;&#10;Description automatically generated">
            <a:extLst>
              <a:ext uri="{FF2B5EF4-FFF2-40B4-BE49-F238E27FC236}">
                <a16:creationId xmlns:a16="http://schemas.microsoft.com/office/drawing/2014/main" id="{221125AC-032E-4CAC-9B11-83CF9C17CCA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07" r="38451"/>
          <a:stretch/>
        </p:blipFill>
        <p:spPr>
          <a:xfrm>
            <a:off x="8148330" y="726779"/>
            <a:ext cx="3839568" cy="50914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C5CD56B-67E3-455F-A69B-ADFD65F5BC0F}"/>
              </a:ext>
            </a:extLst>
          </p:cNvPr>
          <p:cNvSpPr txBox="1"/>
          <p:nvPr/>
        </p:nvSpPr>
        <p:spPr>
          <a:xfrm>
            <a:off x="1352203" y="124687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3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6E6DE36-86AA-4A88-8BA3-5FC80CABD921}"/>
              </a:ext>
            </a:extLst>
          </p:cNvPr>
          <p:cNvSpPr/>
          <p:nvPr/>
        </p:nvSpPr>
        <p:spPr>
          <a:xfrm>
            <a:off x="3462022" y="612950"/>
            <a:ext cx="38183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/>
              <a:t>a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F460687-A28C-460D-B307-98D6FD154E10}"/>
              </a:ext>
            </a:extLst>
          </p:cNvPr>
          <p:cNvSpPr/>
          <p:nvPr/>
        </p:nvSpPr>
        <p:spPr>
          <a:xfrm>
            <a:off x="8025999" y="637014"/>
            <a:ext cx="401072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567589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739B64E-FEF6-4058-8200-769212944C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1085" y="978943"/>
            <a:ext cx="3942366" cy="351914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B4D71A1-0F9E-43D7-B0CE-E22D4077347C}"/>
              </a:ext>
            </a:extLst>
          </p:cNvPr>
          <p:cNvSpPr txBox="1"/>
          <p:nvPr/>
        </p:nvSpPr>
        <p:spPr>
          <a:xfrm>
            <a:off x="1352203" y="124687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4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F196C611-F6F7-46E1-AD8E-1B2C5280DCDB}"/>
              </a:ext>
            </a:extLst>
          </p:cNvPr>
          <p:cNvGrpSpPr/>
          <p:nvPr/>
        </p:nvGrpSpPr>
        <p:grpSpPr>
          <a:xfrm>
            <a:off x="3217030" y="4283747"/>
            <a:ext cx="2913512" cy="346306"/>
            <a:chOff x="2061438" y="3607883"/>
            <a:chExt cx="2913512" cy="346306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3D8FB9A8-05FB-435C-BECE-38992EBEB50D}"/>
                </a:ext>
              </a:extLst>
            </p:cNvPr>
            <p:cNvSpPr/>
            <p:nvPr/>
          </p:nvSpPr>
          <p:spPr>
            <a:xfrm>
              <a:off x="2061438" y="3659904"/>
              <a:ext cx="2893333" cy="29428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7CE78B9-880C-4A5F-917F-E5E4BDE84918}"/>
                </a:ext>
              </a:extLst>
            </p:cNvPr>
            <p:cNvSpPr txBox="1"/>
            <p:nvPr/>
          </p:nvSpPr>
          <p:spPr>
            <a:xfrm>
              <a:off x="2068227" y="3609195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Ctrl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69C240A-96F1-4D80-9A5B-167F8568E21E}"/>
                </a:ext>
              </a:extLst>
            </p:cNvPr>
            <p:cNvSpPr txBox="1"/>
            <p:nvPr/>
          </p:nvSpPr>
          <p:spPr>
            <a:xfrm>
              <a:off x="2487276" y="3614506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2x10</a:t>
              </a:r>
              <a:r>
                <a:rPr lang="en-US" sz="1000" baseline="30000" dirty="0"/>
                <a:t>7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A29F763-F572-4A1F-8FE9-4E069FDDD027}"/>
                </a:ext>
              </a:extLst>
            </p:cNvPr>
            <p:cNvSpPr txBox="1"/>
            <p:nvPr/>
          </p:nvSpPr>
          <p:spPr>
            <a:xfrm>
              <a:off x="2973401" y="3615055"/>
              <a:ext cx="4812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x10</a:t>
              </a:r>
              <a:r>
                <a:rPr lang="en-US" sz="1000" baseline="30000" dirty="0"/>
                <a:t>8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98E998E-1BA3-47BE-8F8F-F6BC84CE9CC6}"/>
                </a:ext>
              </a:extLst>
            </p:cNvPr>
            <p:cNvSpPr txBox="1"/>
            <p:nvPr/>
          </p:nvSpPr>
          <p:spPr>
            <a:xfrm>
              <a:off x="3464038" y="3621129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2x10</a:t>
              </a:r>
              <a:r>
                <a:rPr lang="en-US" sz="1000" baseline="30000" dirty="0"/>
                <a:t>8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EB5EB95-965D-4AA9-9F9F-4D84471B6795}"/>
                </a:ext>
              </a:extLst>
            </p:cNvPr>
            <p:cNvSpPr txBox="1"/>
            <p:nvPr/>
          </p:nvSpPr>
          <p:spPr>
            <a:xfrm>
              <a:off x="3943763" y="3607883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5x10</a:t>
              </a:r>
              <a:r>
                <a:rPr lang="en-US" sz="1000" baseline="30000" dirty="0"/>
                <a:t>8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D01CC2F-9862-4182-80E7-CBC29D05C08C}"/>
                </a:ext>
              </a:extLst>
            </p:cNvPr>
            <p:cNvSpPr txBox="1"/>
            <p:nvPr/>
          </p:nvSpPr>
          <p:spPr>
            <a:xfrm>
              <a:off x="4493728" y="3609211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x10</a:t>
              </a:r>
              <a:r>
                <a:rPr lang="en-US" sz="1000" baseline="30000" dirty="0"/>
                <a:t>9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49E39DA3-B2CE-40D2-A6B6-65B68ACBA42A}"/>
              </a:ext>
            </a:extLst>
          </p:cNvPr>
          <p:cNvSpPr txBox="1"/>
          <p:nvPr/>
        </p:nvSpPr>
        <p:spPr>
          <a:xfrm>
            <a:off x="3602815" y="1621278"/>
            <a:ext cx="5629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0.582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58CA617-D5D0-4324-A8CD-5EF2D5D94B62}"/>
              </a:ext>
            </a:extLst>
          </p:cNvPr>
          <p:cNvSpPr txBox="1"/>
          <p:nvPr/>
        </p:nvSpPr>
        <p:spPr>
          <a:xfrm>
            <a:off x="4040965" y="1821303"/>
            <a:ext cx="6303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&gt;0.999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3CB6948-0BB3-413E-9651-A71ADEDC2221}"/>
              </a:ext>
            </a:extLst>
          </p:cNvPr>
          <p:cNvSpPr txBox="1"/>
          <p:nvPr/>
        </p:nvSpPr>
        <p:spPr>
          <a:xfrm>
            <a:off x="4564840" y="1935603"/>
            <a:ext cx="5629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/>
              <a:t>0.7349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24EB71F-AAA5-4962-957D-5EA5153AE304}"/>
              </a:ext>
            </a:extLst>
          </p:cNvPr>
          <p:cNvSpPr txBox="1"/>
          <p:nvPr/>
        </p:nvSpPr>
        <p:spPr>
          <a:xfrm>
            <a:off x="5031565" y="2049903"/>
            <a:ext cx="5629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0.793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A0DE86-AB16-4443-A2F1-B39224E51270}"/>
              </a:ext>
            </a:extLst>
          </p:cNvPr>
          <p:cNvSpPr txBox="1"/>
          <p:nvPr/>
        </p:nvSpPr>
        <p:spPr>
          <a:xfrm>
            <a:off x="5536390" y="2754753"/>
            <a:ext cx="5629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0.0016</a:t>
            </a:r>
          </a:p>
        </p:txBody>
      </p:sp>
    </p:spTree>
    <p:extLst>
      <p:ext uri="{BB962C8B-B14F-4D97-AF65-F5344CB8AC3E}">
        <p14:creationId xmlns:p14="http://schemas.microsoft.com/office/powerpoint/2010/main" val="31595706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484A1703-85D2-41A3-8A1B-5766650A06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0453" y="874409"/>
            <a:ext cx="3837772" cy="272821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96E53B9B-010F-408C-8131-03DEA7FE2AA9}"/>
              </a:ext>
            </a:extLst>
          </p:cNvPr>
          <p:cNvSpPr txBox="1"/>
          <p:nvPr/>
        </p:nvSpPr>
        <p:spPr>
          <a:xfrm>
            <a:off x="219699" y="98559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5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A667942-417D-4379-85EE-6EEBD2064325}"/>
              </a:ext>
            </a:extLst>
          </p:cNvPr>
          <p:cNvSpPr/>
          <p:nvPr/>
        </p:nvSpPr>
        <p:spPr>
          <a:xfrm>
            <a:off x="1338076" y="582022"/>
            <a:ext cx="38183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/>
              <a:t>a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3F5D1BF-F6A2-4A53-A20E-6AFC98938B1D}"/>
              </a:ext>
            </a:extLst>
          </p:cNvPr>
          <p:cNvSpPr/>
          <p:nvPr/>
        </p:nvSpPr>
        <p:spPr>
          <a:xfrm>
            <a:off x="6305679" y="98559"/>
            <a:ext cx="401072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/>
              <a:t>b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911ABD9A-BCDC-4B4B-A275-7C021B5C9CED}"/>
              </a:ext>
            </a:extLst>
          </p:cNvPr>
          <p:cNvGrpSpPr/>
          <p:nvPr/>
        </p:nvGrpSpPr>
        <p:grpSpPr>
          <a:xfrm>
            <a:off x="6875291" y="0"/>
            <a:ext cx="7552528" cy="8190632"/>
            <a:chOff x="2545511" y="4355154"/>
            <a:chExt cx="7552528" cy="8190632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8260703-4545-4C4C-91B3-355CE9303EC5}"/>
                </a:ext>
              </a:extLst>
            </p:cNvPr>
            <p:cNvGrpSpPr/>
            <p:nvPr/>
          </p:nvGrpSpPr>
          <p:grpSpPr>
            <a:xfrm>
              <a:off x="2545511" y="4355154"/>
              <a:ext cx="7552528" cy="8190632"/>
              <a:chOff x="4390351" y="970269"/>
              <a:chExt cx="7552528" cy="8190632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93828CAD-1B54-4937-A3B0-D03F45B378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407267" y="970269"/>
                <a:ext cx="2253396" cy="269748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09301971-9FC8-4CA2-9359-A81FB5F8A0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390692" y="3714368"/>
                <a:ext cx="2253779" cy="2697480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16F663A1-A0A8-4093-93B9-E9A207A95A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390351" y="6460086"/>
                <a:ext cx="2254120" cy="269748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3CBA68AB-3B82-4579-86AD-B59C4D9E3C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223818" y="971501"/>
                <a:ext cx="2258957" cy="2697480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6FA7CC7F-6CB9-492A-A314-9013591865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218017" y="3717223"/>
                <a:ext cx="2249915" cy="2697480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D6DD0C5C-772F-4A50-BF3F-827217A401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222831" y="6456176"/>
                <a:ext cx="2253396" cy="2697480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6306E15F-E0F9-4986-852D-EFAE12C7F2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051584" y="972552"/>
                <a:ext cx="2258904" cy="269748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47594150-7C4D-4EBC-B0FC-59912818F0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8094697" y="3658084"/>
                <a:ext cx="2247690" cy="2697480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B17BD3B3-CD2B-49AB-9167-F0B5F4246B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8050757" y="6455117"/>
                <a:ext cx="2257950" cy="2697480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95044A40-48BB-4AD3-9037-D51987042F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r="8930"/>
              <a:stretch/>
            </p:blipFill>
            <p:spPr>
              <a:xfrm>
                <a:off x="9873696" y="970269"/>
                <a:ext cx="2052065" cy="2697480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E888EF01-FC73-4B85-A12A-40917F092A8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r="11845"/>
              <a:stretch/>
            </p:blipFill>
            <p:spPr>
              <a:xfrm>
                <a:off x="9944230" y="3666388"/>
                <a:ext cx="1981532" cy="2697480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00DAA34B-E7BB-4766-B540-5F043364319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r="9098"/>
              <a:stretch/>
            </p:blipFill>
            <p:spPr>
              <a:xfrm>
                <a:off x="9890814" y="6463421"/>
                <a:ext cx="2052065" cy="2697480"/>
              </a:xfrm>
              <a:prstGeom prst="rect">
                <a:avLst/>
              </a:prstGeom>
            </p:spPr>
          </p:pic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493BA5D-1FFC-4BDE-B965-8A9E9A084739}"/>
                </a:ext>
              </a:extLst>
            </p:cNvPr>
            <p:cNvSpPr txBox="1"/>
            <p:nvPr/>
          </p:nvSpPr>
          <p:spPr>
            <a:xfrm>
              <a:off x="5587807" y="4726789"/>
              <a:ext cx="5629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067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1D2048F-47BA-4679-B110-1D61764CCC97}"/>
                </a:ext>
              </a:extLst>
            </p:cNvPr>
            <p:cNvSpPr txBox="1"/>
            <p:nvPr/>
          </p:nvSpPr>
          <p:spPr>
            <a:xfrm>
              <a:off x="7441525" y="4889843"/>
              <a:ext cx="5629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001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8EEA2B7-A1D1-4766-9601-2B8146C10A92}"/>
                </a:ext>
              </a:extLst>
            </p:cNvPr>
            <p:cNvSpPr txBox="1"/>
            <p:nvPr/>
          </p:nvSpPr>
          <p:spPr>
            <a:xfrm>
              <a:off x="9196311" y="4823045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&lt;0.000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9B3DF85-51A7-4A19-BB47-A7443BCEF658}"/>
                </a:ext>
              </a:extLst>
            </p:cNvPr>
            <p:cNvSpPr txBox="1"/>
            <p:nvPr/>
          </p:nvSpPr>
          <p:spPr>
            <a:xfrm>
              <a:off x="3802611" y="5268035"/>
              <a:ext cx="5629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000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9078828-4747-4E5D-84FE-9F545DB62176}"/>
                </a:ext>
              </a:extLst>
            </p:cNvPr>
            <p:cNvSpPr txBox="1"/>
            <p:nvPr/>
          </p:nvSpPr>
          <p:spPr>
            <a:xfrm>
              <a:off x="3749594" y="8031067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dirty="0"/>
                <a:t>&lt;0.000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D87F1F6-D992-49EF-BE91-8A696DDA7623}"/>
                </a:ext>
              </a:extLst>
            </p:cNvPr>
            <p:cNvSpPr txBox="1"/>
            <p:nvPr/>
          </p:nvSpPr>
          <p:spPr>
            <a:xfrm>
              <a:off x="5581918" y="7963488"/>
              <a:ext cx="5629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000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5961444-2E44-4DED-9AB7-8AD90A5189DD}"/>
                </a:ext>
              </a:extLst>
            </p:cNvPr>
            <p:cNvSpPr txBox="1"/>
            <p:nvPr/>
          </p:nvSpPr>
          <p:spPr>
            <a:xfrm>
              <a:off x="7489945" y="7315199"/>
              <a:ext cx="49404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017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56B7573-C6D3-43BA-B987-40F198FA2154}"/>
                </a:ext>
              </a:extLst>
            </p:cNvPr>
            <p:cNvSpPr txBox="1"/>
            <p:nvPr/>
          </p:nvSpPr>
          <p:spPr>
            <a:xfrm>
              <a:off x="9314731" y="7335252"/>
              <a:ext cx="5629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0107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A332B1D-2071-4FC4-9730-E97F5D16CCAB}"/>
                </a:ext>
              </a:extLst>
            </p:cNvPr>
            <p:cNvSpPr txBox="1"/>
            <p:nvPr/>
          </p:nvSpPr>
          <p:spPr>
            <a:xfrm>
              <a:off x="3772184" y="10539668"/>
              <a:ext cx="5629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6966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D5479E6-C180-4C10-8BC0-54FE62962309}"/>
                </a:ext>
              </a:extLst>
            </p:cNvPr>
            <p:cNvSpPr txBox="1"/>
            <p:nvPr/>
          </p:nvSpPr>
          <p:spPr>
            <a:xfrm>
              <a:off x="5609007" y="10246900"/>
              <a:ext cx="5629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0792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CFC4698-8E87-4833-88FA-181F6058415A}"/>
                </a:ext>
              </a:extLst>
            </p:cNvPr>
            <p:cNvSpPr txBox="1"/>
            <p:nvPr/>
          </p:nvSpPr>
          <p:spPr>
            <a:xfrm>
              <a:off x="7433792" y="10110544"/>
              <a:ext cx="5629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9197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7FC89B0-5777-450C-A348-E3D4B73A1D31}"/>
                </a:ext>
              </a:extLst>
            </p:cNvPr>
            <p:cNvSpPr txBox="1"/>
            <p:nvPr/>
          </p:nvSpPr>
          <p:spPr>
            <a:xfrm>
              <a:off x="9270616" y="10262944"/>
              <a:ext cx="56297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0.000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074423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31BF09B-9DC7-4DB4-BB99-B1505D4C34FF}"/>
              </a:ext>
            </a:extLst>
          </p:cNvPr>
          <p:cNvSpPr txBox="1"/>
          <p:nvPr/>
        </p:nvSpPr>
        <p:spPr>
          <a:xfrm>
            <a:off x="1352203" y="124687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3EAB108-6AA8-418C-BC04-2863D27EE4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2800" y="968122"/>
            <a:ext cx="5244551" cy="460249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FA7A34C-D685-44A8-BB80-F0AA4E6CBE3F}"/>
              </a:ext>
            </a:extLst>
          </p:cNvPr>
          <p:cNvSpPr txBox="1"/>
          <p:nvPr/>
        </p:nvSpPr>
        <p:spPr>
          <a:xfrm>
            <a:off x="4168077" y="1466229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0.00006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0CC4ED8-B3EE-4049-B433-D0901C145E63}"/>
              </a:ext>
            </a:extLst>
          </p:cNvPr>
          <p:cNvSpPr txBox="1"/>
          <p:nvPr/>
        </p:nvSpPr>
        <p:spPr>
          <a:xfrm>
            <a:off x="5054406" y="1763010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0.00982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BFB1D0-8E4E-4E26-9DF6-F285A391949C}"/>
              </a:ext>
            </a:extLst>
          </p:cNvPr>
          <p:cNvSpPr txBox="1"/>
          <p:nvPr/>
        </p:nvSpPr>
        <p:spPr>
          <a:xfrm>
            <a:off x="5856516" y="1987599"/>
            <a:ext cx="70083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0.044776</a:t>
            </a:r>
          </a:p>
          <a:p>
            <a:pPr algn="ctr"/>
            <a:endParaRPr lang="en-US" sz="1050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92C001AC-93F1-441B-868E-6ECA259F138D}"/>
              </a:ext>
            </a:extLst>
          </p:cNvPr>
          <p:cNvCxnSpPr>
            <a:cxnSpLocks/>
          </p:cNvCxnSpPr>
          <p:nvPr/>
        </p:nvCxnSpPr>
        <p:spPr>
          <a:xfrm>
            <a:off x="6898106" y="2105526"/>
            <a:ext cx="32485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DE4AF951-36F5-4EBF-A03E-F769B96AA162}"/>
              </a:ext>
            </a:extLst>
          </p:cNvPr>
          <p:cNvSpPr txBox="1"/>
          <p:nvPr/>
        </p:nvSpPr>
        <p:spPr>
          <a:xfrm>
            <a:off x="6682687" y="1863271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0.072826</a:t>
            </a:r>
          </a:p>
        </p:txBody>
      </p:sp>
    </p:spTree>
    <p:extLst>
      <p:ext uri="{BB962C8B-B14F-4D97-AF65-F5344CB8AC3E}">
        <p14:creationId xmlns:p14="http://schemas.microsoft.com/office/powerpoint/2010/main" val="4229842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8</TotalTime>
  <Words>66</Words>
  <Application>Microsoft Office PowerPoint</Application>
  <PresentationFormat>Custom</PresentationFormat>
  <Paragraphs>4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rnando Santiago</dc:creator>
  <cp:lastModifiedBy>Fernando Santiago</cp:lastModifiedBy>
  <cp:revision>5</cp:revision>
  <cp:lastPrinted>2021-01-27T21:14:43Z</cp:lastPrinted>
  <dcterms:created xsi:type="dcterms:W3CDTF">2020-11-17T16:27:56Z</dcterms:created>
  <dcterms:modified xsi:type="dcterms:W3CDTF">2021-01-27T21:36:10Z</dcterms:modified>
</cp:coreProperties>
</file>